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2" autoAdjust="0"/>
    <p:restoredTop sz="94660"/>
  </p:normalViewPr>
  <p:slideViewPr>
    <p:cSldViewPr>
      <p:cViewPr varScale="1">
        <p:scale>
          <a:sx n="45" d="100"/>
          <a:sy n="45" d="100"/>
        </p:scale>
        <p:origin x="2232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729E5-2BCF-4995-BBDD-1F60F1826250}" type="datetimeFigureOut">
              <a:rPr lang="en-GB" smtClean="0"/>
              <a:t>02/09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3E557D-A068-4F09-A9EE-3666FBCBBC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6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12E4F6-A686-4B6F-8528-706B3B1CC703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081902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A97C-6094-44F3-9AD2-0A11796E8BE7}" type="datetimeFigureOut">
              <a:rPr lang="en-US" smtClean="0"/>
              <a:t>9/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88D163-8FEE-4B6A-977D-600E3843CE6C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305272" y="1115616"/>
          <a:ext cx="6264696" cy="2884359"/>
        </p:xfrm>
        <a:graphic>
          <a:graphicData uri="http://schemas.openxmlformats.org/drawingml/2006/table">
            <a:tbl>
              <a:tblPr/>
              <a:tblGrid>
                <a:gridCol w="648072"/>
                <a:gridCol w="576064"/>
                <a:gridCol w="432048"/>
                <a:gridCol w="576064"/>
                <a:gridCol w="432048"/>
                <a:gridCol w="517848"/>
                <a:gridCol w="432048"/>
                <a:gridCol w="490264"/>
                <a:gridCol w="432048"/>
                <a:gridCol w="504056"/>
                <a:gridCol w="360040"/>
                <a:gridCol w="504056"/>
                <a:gridCol w="360040"/>
              </a:tblGrid>
              <a:tr h="12227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rotein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ORF37</a:t>
                      </a: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ORF50-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ORF50-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 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GB" sz="900" kern="12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 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GB" sz="900" kern="12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 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GB" sz="900" kern="12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GB" sz="9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bai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25951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ique peptides</a:t>
                      </a: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SM’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ique peptides</a:t>
                      </a: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SM’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ique peptides</a:t>
                      </a: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SM’s</a:t>
                      </a: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ique peptides</a:t>
                      </a: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SM’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ique peptides</a:t>
                      </a: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SM’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nique peptides</a:t>
                      </a: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SM’s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450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RPF6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U2AF2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RMB39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1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RPF4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4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ELAVL1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 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DX5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TBP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SNRNP4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SP39 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RPF1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hnRNPQ</a:t>
                      </a:r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4278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LY/REF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8051" marR="8051" marT="805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8500748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2007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</TotalTime>
  <Words>189</Words>
  <Application>Microsoft Office PowerPoint</Application>
  <PresentationFormat>On-screen Show (4:3)</PresentationFormat>
  <Paragraphs>17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2007Blank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linda Baquero</dc:creator>
  <cp:lastModifiedBy>Belinda Baquero</cp:lastModifiedBy>
  <cp:revision>1</cp:revision>
  <dcterms:created xsi:type="dcterms:W3CDTF">2019-09-02T18:30:15Z</dcterms:created>
  <dcterms:modified xsi:type="dcterms:W3CDTF">2019-09-02T18:31:36Z</dcterms:modified>
</cp:coreProperties>
</file>